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93455" r:id="rId4"/>
  </p:sldMasterIdLst>
  <p:notesMasterIdLst>
    <p:notesMasterId r:id="rId21"/>
  </p:notesMasterIdLst>
  <p:sldIdLst>
    <p:sldId id="283" r:id="rId5"/>
    <p:sldId id="285" r:id="rId6"/>
    <p:sldId id="337" r:id="rId7"/>
    <p:sldId id="326" r:id="rId8"/>
    <p:sldId id="335" r:id="rId9"/>
    <p:sldId id="328" r:id="rId10"/>
    <p:sldId id="331" r:id="rId11"/>
    <p:sldId id="336" r:id="rId12"/>
    <p:sldId id="333" r:id="rId13"/>
    <p:sldId id="334" r:id="rId14"/>
    <p:sldId id="330" r:id="rId15"/>
    <p:sldId id="332" r:id="rId16"/>
    <p:sldId id="340" r:id="rId17"/>
    <p:sldId id="339" r:id="rId18"/>
    <p:sldId id="338" r:id="rId19"/>
    <p:sldId id="325" r:id="rId20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3012" userDrawn="1">
          <p15:clr>
            <a:srgbClr val="A4A3A4"/>
          </p15:clr>
        </p15:guide>
        <p15:guide id="3" orient="horz" pos="1620">
          <p15:clr>
            <a:srgbClr val="A4A3A4"/>
          </p15:clr>
        </p15:guide>
        <p15:guide id="4" orient="horz" pos="120">
          <p15:clr>
            <a:srgbClr val="A4A3A4"/>
          </p15:clr>
        </p15:guide>
        <p15:guide id="5" orient="horz" pos="756" userDrawn="1">
          <p15:clr>
            <a:srgbClr val="A4A3A4"/>
          </p15:clr>
        </p15:guide>
        <p15:guide id="6" pos="432">
          <p15:clr>
            <a:srgbClr val="A4A3A4"/>
          </p15:clr>
        </p15:guide>
        <p15:guide id="7" pos="5478">
          <p15:clr>
            <a:srgbClr val="A4A3A4"/>
          </p15:clr>
        </p15:guide>
        <p15:guide id="8" pos="2879">
          <p15:clr>
            <a:srgbClr val="A4A3A4"/>
          </p15:clr>
        </p15:guide>
        <p15:guide id="9" orient="horz" pos="424">
          <p15:clr>
            <a:srgbClr val="A4A3A4"/>
          </p15:clr>
        </p15:guide>
        <p15:guide id="10" pos="4781">
          <p15:clr>
            <a:srgbClr val="A4A3A4"/>
          </p15:clr>
        </p15:guide>
        <p15:guide id="11" pos="5471">
          <p15:clr>
            <a:srgbClr val="A4A3A4"/>
          </p15:clr>
        </p15:guide>
        <p15:guide id="12" pos="42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D2D2D"/>
    <a:srgbClr val="EDEDEB"/>
    <a:srgbClr val="DBD6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33E12B4-DE65-4977-A91A-7573F37C7A94}" v="316" dt="2021-03-12T13:53:52.30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31" autoAdjust="0"/>
    <p:restoredTop sz="91547"/>
  </p:normalViewPr>
  <p:slideViewPr>
    <p:cSldViewPr snapToGrid="0" snapToObjects="1">
      <p:cViewPr varScale="1">
        <p:scale>
          <a:sx n="165" d="100"/>
          <a:sy n="165" d="100"/>
        </p:scale>
        <p:origin x="1192" y="184"/>
      </p:cViewPr>
      <p:guideLst>
        <p:guide orient="horz" pos="3012"/>
        <p:guide orient="horz" pos="1620"/>
        <p:guide orient="horz" pos="120"/>
        <p:guide orient="horz" pos="756"/>
        <p:guide pos="432"/>
        <p:guide pos="5478"/>
        <p:guide pos="2879"/>
        <p:guide orient="horz" pos="424"/>
        <p:guide pos="4781"/>
        <p:guide pos="5471"/>
        <p:guide pos="426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9" d="100"/>
        <a:sy n="149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microsoft.com/office/2015/10/relationships/revisionInfo" Target="revisionInfo.xml"/><Relationship Id="rId3" Type="http://schemas.openxmlformats.org/officeDocument/2006/relationships/customXml" Target="../customXml/item3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theme" Target="theme/theme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viewProps" Target="view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42E0F2-B694-C44C-A396-27B6C59A926F}" type="datetimeFigureOut">
              <a:rPr lang="en-US" smtClean="0"/>
              <a:t>4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E6F44A-B88D-2946-8FFA-91DB132F0E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1495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E6F44A-B88D-2946-8FFA-91DB132F0EC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0563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379933"/>
            <a:ext cx="5943600" cy="185990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4375153"/>
            <a:ext cx="5943600" cy="576072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3393851"/>
            <a:ext cx="5943600" cy="509588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032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2714558"/>
            <a:ext cx="6904037" cy="4606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2571464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3300413"/>
            <a:ext cx="6904038" cy="13716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0746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314599"/>
            <a:ext cx="6904038" cy="40915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627585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218054"/>
            <a:ext cx="9144000" cy="3932237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441137"/>
            <a:ext cx="6904038" cy="694386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40122"/>
            <a:ext cx="793487" cy="320040"/>
          </a:xfrm>
          <a:prstGeom prst="rect">
            <a:avLst/>
          </a:prstGeom>
        </p:spPr>
      </p:pic>
      <p:sp>
        <p:nvSpPr>
          <p:cNvPr id="14" name="Rectangle 13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003258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4210210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/>
          <p:cNvSpPr txBox="1"/>
          <p:nvPr userDrawn="1"/>
        </p:nvSpPr>
        <p:spPr>
          <a:xfrm>
            <a:off x="685800" y="1027380"/>
            <a:ext cx="2279959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4389120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326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 userDrawn="1"/>
        </p:nvSpPr>
        <p:spPr>
          <a:xfrm>
            <a:off x="0" y="0"/>
            <a:ext cx="9144000" cy="51435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1432720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783766"/>
            <a:ext cx="5943600" cy="186987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3983716"/>
            <a:ext cx="5943600" cy="797834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2" y="466344"/>
            <a:ext cx="4116387" cy="561684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587088" y="303091"/>
            <a:ext cx="1360263" cy="548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7318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47975"/>
            <a:ext cx="6904038" cy="802243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190935"/>
            <a:ext cx="6904038" cy="351531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9891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84578"/>
            <a:ext cx="6904037" cy="80467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946275"/>
            <a:ext cx="6904038" cy="2743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315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2972870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457200"/>
            <a:ext cx="6904037" cy="1922122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3062288"/>
            <a:ext cx="6904038" cy="16192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9196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0"/>
            <a:ext cx="9144000" cy="18288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37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27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27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1755775"/>
            <a:ext cx="3811588" cy="28146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8520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 userDrawn="1"/>
        </p:nvSpPr>
        <p:spPr>
          <a:xfrm rot="10800000">
            <a:off x="0" y="0"/>
            <a:ext cx="9144000" cy="964090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067180"/>
            <a:ext cx="8001000" cy="78273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8" y="1969780"/>
            <a:ext cx="3811589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969780"/>
            <a:ext cx="3813086" cy="390339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2444750"/>
            <a:ext cx="3811588" cy="22145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4827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257175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7" y="2700906"/>
            <a:ext cx="3008313" cy="624885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7" y="3396227"/>
            <a:ext cx="3008313" cy="1318664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8220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51435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8" name="Rectangle 7"/>
          <p:cNvSpPr/>
          <p:nvPr userDrawn="1"/>
        </p:nvSpPr>
        <p:spPr>
          <a:xfrm>
            <a:off x="0" y="0"/>
            <a:ext cx="5257800" cy="51435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635029"/>
            <a:ext cx="3884612" cy="1292036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0" y="2030413"/>
            <a:ext cx="3884613" cy="2647157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4773168"/>
            <a:ext cx="4187952" cy="27432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902838" y="4735710"/>
            <a:ext cx="793487" cy="32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5255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05979"/>
            <a:ext cx="8001000" cy="85725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200151"/>
            <a:ext cx="8001000" cy="3394472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4773168"/>
            <a:ext cx="6519672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4773168"/>
            <a:ext cx="310896" cy="27432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E0E041CE-D44E-914D-B85F-4D1E2534846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3843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93505" r:id="rId1"/>
    <p:sldLayoutId id="2147493508" r:id="rId2"/>
    <p:sldLayoutId id="2147493511" r:id="rId3"/>
    <p:sldLayoutId id="2147493468" r:id="rId4"/>
    <p:sldLayoutId id="2147493470" r:id="rId5"/>
    <p:sldLayoutId id="2147493489" r:id="rId6"/>
    <p:sldLayoutId id="2147493471" r:id="rId7"/>
    <p:sldLayoutId id="2147493463" r:id="rId8"/>
    <p:sldLayoutId id="2147493513" r:id="rId9"/>
    <p:sldLayoutId id="2147493474" r:id="rId10"/>
    <p:sldLayoutId id="2147493491" r:id="rId11"/>
    <p:sldLayoutId id="2147493512" r:id="rId12"/>
    <p:sldLayoutId id="2147493483" r:id="rId13"/>
  </p:sldLayoutIdLst>
  <p:hf hdr="0" ftr="0" dt="0"/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uptodate.com/contents/diabetic-ketoacidosis-and-hyperosmolar-hyperglycemic-state-in-adults-clinical-features-evaluation-and-diagnosis" TargetMode="External"/><Relationship Id="rId2" Type="http://schemas.openxmlformats.org/officeDocument/2006/relationships/hyperlink" Target="http://www.diabetes.org/diabetes-basics/?loc=db-slabnav" TargetMode="External"/><Relationship Id="rId1" Type="http://schemas.openxmlformats.org/officeDocument/2006/relationships/slideLayout" Target="../slideLayouts/slideLayout4.xml"/><Relationship Id="rId4" Type="http://schemas.openxmlformats.org/officeDocument/2006/relationships/hyperlink" Target="https://www.uptodate.com/contents/hypoglycemia-in-adults-without-diabetes-mellitus-clinical-manifestations-diagnosis-and-causes" TargetMode="Externa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4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US" dirty="0"/>
              <a:t>Division of Observation Medicine</a:t>
            </a:r>
          </a:p>
        </p:txBody>
      </p:sp>
      <p:sp>
        <p:nvSpPr>
          <p:cNvPr id="4" name="Title 3"/>
          <p:cNvSpPr>
            <a:spLocks noGrp="1"/>
          </p:cNvSpPr>
          <p:nvPr>
            <p:ph type="ctrTitle"/>
          </p:nvPr>
        </p:nvSpPr>
        <p:spPr>
          <a:xfrm>
            <a:off x="685799" y="1379933"/>
            <a:ext cx="8000999" cy="1859909"/>
          </a:xfrm>
        </p:spPr>
        <p:txBody>
          <a:bodyPr/>
          <a:lstStyle/>
          <a:p>
            <a:pPr algn="ctr"/>
            <a:r>
              <a:rPr lang="en-US" sz="3600" dirty="0"/>
              <a:t>HYPER &amp; HYPOGLYCEMIA</a:t>
            </a:r>
            <a:br>
              <a:rPr lang="en-US" sz="3600" dirty="0"/>
            </a:br>
            <a:br>
              <a:rPr lang="en-US" sz="3600" dirty="0"/>
            </a:br>
            <a:r>
              <a:rPr lang="en-US" sz="2400" dirty="0"/>
              <a:t>Managing DYSGLYCEMIA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2177983-9455-D64E-A8CB-A59A1DE9E25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03538" y="4572703"/>
            <a:ext cx="1422400" cy="4826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48B5371-53E1-874A-B866-3CCCEF2B0BD6}"/>
              </a:ext>
            </a:extLst>
          </p:cNvPr>
          <p:cNvSpPr txBox="1"/>
          <p:nvPr/>
        </p:nvSpPr>
        <p:spPr>
          <a:xfrm>
            <a:off x="9686441" y="4641742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90726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389204-0357-6842-AE76-E923C5C98F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YMPTOMS OF </a:t>
            </a:r>
            <a:r>
              <a:rPr lang="en-US" i="1" dirty="0"/>
              <a:t>HYPO</a:t>
            </a:r>
            <a:r>
              <a:rPr lang="en-US" dirty="0"/>
              <a:t>GLYC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799467-24F6-214B-A29E-040F66D8BFCC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 vert="horz" lIns="0" tIns="0" rIns="0" bIns="0" numCol="2" rtlCol="0" anchor="t">
            <a:normAutofit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nxiety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Tremor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Palpitation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Sweating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Paresthesia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Hunger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Confusion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Drowsines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Weaknes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Dizzines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Blurry vision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Seizure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57D036-FFAB-984C-B816-D71863826828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1803429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6BBFD3-A180-6849-8AA6-63A23B45FA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HYPO</a:t>
            </a:r>
            <a:r>
              <a:rPr lang="en-US" dirty="0"/>
              <a:t>GLYCEMIA</a:t>
            </a:r>
            <a:br>
              <a:rPr lang="en-US" dirty="0"/>
            </a:br>
            <a:r>
              <a:rPr lang="en-US" u="sng" dirty="0"/>
              <a:t>EXCLUSION</a:t>
            </a:r>
            <a:r>
              <a:rPr lang="en-US" dirty="0"/>
              <a:t> CRITERIA FOR OBSERV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CC5233-2602-3943-A5B5-3F5A569CE749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Non-diabetics with hypoglycemia</a:t>
            </a:r>
          </a:p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Overdose of hypoglycemic medications with refractory hypoglycemia despite treatment (blood glucose </a:t>
            </a:r>
            <a:r>
              <a:rPr lang="en-US" dirty="0">
                <a:sym typeface="Symbol" pitchFamily="2" charset="2"/>
              </a:rPr>
              <a:t></a:t>
            </a:r>
            <a:r>
              <a:rPr lang="en-US" dirty="0"/>
              <a:t> 70 for </a:t>
            </a:r>
            <a:r>
              <a:rPr lang="en-US" dirty="0">
                <a:sym typeface="Symbol" pitchFamily="2" charset="2"/>
              </a:rPr>
              <a:t></a:t>
            </a:r>
            <a:r>
              <a:rPr lang="en-US" dirty="0"/>
              <a:t> 2 readings 2 hours apart)</a:t>
            </a:r>
          </a:p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Intake of large amounts of long-acting oral hypoglycemics</a:t>
            </a:r>
          </a:p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Inability to tolerate PO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>
                <a:solidFill>
                  <a:srgbClr val="FF0000"/>
                </a:solidFill>
              </a:rPr>
              <a:t>AMS</a:t>
            </a:r>
            <a:r>
              <a:rPr lang="en-US" dirty="0"/>
              <a:t> despite glucose administration 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802A91-E92E-B840-8530-C147649FD045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448416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AFD605-8E5E-9D4D-B781-4184DA2E8E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HYPO</a:t>
            </a:r>
            <a:r>
              <a:rPr lang="en-US" dirty="0"/>
              <a:t>GLYCEMIA</a:t>
            </a:r>
            <a:br>
              <a:rPr lang="en-US" dirty="0"/>
            </a:br>
            <a:r>
              <a:rPr lang="en-US" dirty="0"/>
              <a:t>MANAGEMENT DURING OBSERV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8E15F8-22CF-7745-901F-0C98BCF72DEB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 vert="horz" lIns="0" tIns="0" rIns="0" bIns="0" rtlCol="0" anchor="t">
            <a:normAutofit/>
          </a:bodyPr>
          <a:lstStyle/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Hold Insulin and oral hypoglycemics that cause hypoglycemia (ie, Sulfonylureas, Glinides)</a:t>
            </a:r>
          </a:p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Can continue oral hypoglycemics that do NOT cause hypoglycemia (ie, Metformin, Glucagon-like peptide-1 (GLP-1) receptor agonists, dipeptidyl peptidase 4 (DPP-4) inhibitors)</a:t>
            </a:r>
          </a:p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Hold medications that cause hypoglycemia (ie, Quinolones, ACE-I, B-blockers, etc.)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Monitor blood glucose q4 hours</a:t>
            </a:r>
            <a:endParaRPr lang="en-US" dirty="0">
              <a:cs typeface="Arial"/>
            </a:endParaRPr>
          </a:p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Glycemic control consult</a:t>
            </a:r>
          </a:p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0B8E861-28FF-8E40-A9C9-65DEFE0E2D6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535389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C60484-5634-774D-90BC-EC7EAB24F5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OW TO PREVENT </a:t>
            </a:r>
            <a:r>
              <a:rPr lang="en-US" i="1" dirty="0"/>
              <a:t>HYPO</a:t>
            </a:r>
            <a:r>
              <a:rPr lang="en-US" dirty="0"/>
              <a:t>GLYC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5DD81C-C621-684F-AE74-A96E80043B56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>
            <a:normAutofit fontScale="92500" lnSpcReduction="20000"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Monitor blood glucose frequently!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Before &amp; after meals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Before bed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Before &amp; after exercise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In the middle of the night after intense exercise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After starting a new insulin regimen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While traveling to different time zones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After a change in work schedule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59A6B84-631D-2C49-A81C-C09F7BEA2C66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64352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BAA528-3905-5D48-9D6C-450805FFA1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15-15 RULE OF </a:t>
            </a:r>
            <a:r>
              <a:rPr lang="en-US" i="1" dirty="0"/>
              <a:t>HYPO</a:t>
            </a:r>
            <a:r>
              <a:rPr lang="en-US" dirty="0"/>
              <a:t>GLYC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DD05AE-3D59-7346-B617-BAFABDD08928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627632"/>
            <a:ext cx="6904038" cy="3061843"/>
          </a:xfrm>
        </p:spPr>
        <p:txBody>
          <a:bodyPr>
            <a:normAutofit fontScale="70000" lnSpcReduction="20000"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b="1" dirty="0"/>
              <a:t>15 grams </a:t>
            </a:r>
            <a:r>
              <a:rPr lang="en-US" dirty="0"/>
              <a:t>of carbohydrates will raise blood glucose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Recheck blood glucose after </a:t>
            </a:r>
            <a:r>
              <a:rPr lang="en-US" b="1" dirty="0"/>
              <a:t>15 minute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Continue to have another serving if blood glucose remains &lt; 70 mg/dL after 15 minute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fter obtaining blood glucose ≥ 70 mg/dL, eat a snack or meal: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Gel tube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Glucose tablets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Regular soda or juice (4 oz)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Nonfat or 1% milk (8 oz)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Jelly beans, hard candy, or gum drops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Of note, avoid complex carbs which contain fats because they slow absorption of glucose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20CBB5-B762-0942-885F-D02143302342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0773427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C2368-608C-194D-8353-D9F5B9729B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EN TO ADMI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5659A0-3120-9947-B2CD-0AB09D15FBD9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Deterioration of clinical statu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Inability to adequately treat precipitating factor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Persistent metabolic derangement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Cardiac dysrhythmia or EKG changes</a:t>
            </a:r>
          </a:p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9B6352-B1AA-874D-9CC1-6F088E7679D2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091221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DA6368-7F9F-4C48-9AFF-A8A774BF65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0E0E1D-84A5-BC42-85E0-91BD899DB8B2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595535"/>
            <a:ext cx="6904038" cy="3093940"/>
          </a:xfrm>
        </p:spPr>
        <p:txBody>
          <a:bodyPr vert="horz" lIns="0" tIns="0" rIns="0" bIns="0" rtlCol="0" anchor="t">
            <a:normAutofit fontScale="92500" lnSpcReduction="10000"/>
          </a:bodyPr>
          <a:lstStyle/>
          <a:p>
            <a:r>
              <a:rPr lang="en-US" dirty="0"/>
              <a:t>1. American Diabetes Association. Diabetes Basics. American Diabetes Association Website. Published 2019. Accessed March 12, 2021. Available at: </a:t>
            </a:r>
            <a:r>
              <a:rPr lang="en-US" dirty="0">
                <a:hlinkClick r:id="rId2"/>
              </a:rPr>
              <a:t>http://www.diabetes.org/diabetes-basics/?loc=db-slabnav</a:t>
            </a:r>
            <a:r>
              <a:rPr lang="en-US" dirty="0"/>
              <a:t>.</a:t>
            </a:r>
          </a:p>
          <a:p>
            <a:r>
              <a:rPr lang="en-US" dirty="0"/>
              <a:t>2. Hirsch I, Emmett M. Diabetic ketoacidosis and hyperosmolar hyperglycemic state in adults: Clinical features, evaluation, and diagnosis. Uptodate.com. Updated March 29, 2020. Accessed March 12, 2021. Available at:</a:t>
            </a:r>
            <a:r>
              <a:rPr lang="en-US" dirty="0">
                <a:ea typeface="+mn-lt"/>
                <a:cs typeface="+mn-lt"/>
              </a:rPr>
              <a:t> </a:t>
            </a:r>
            <a:r>
              <a:rPr lang="en-US" dirty="0">
                <a:ea typeface="+mn-lt"/>
                <a:cs typeface="+mn-lt"/>
                <a:hlinkClick r:id="rId3"/>
              </a:rPr>
              <a:t>https://www.uptodate.com/contents/diabetic-ketoacidosis-and-hyperosmolar-hyperglycemic-state-in-adults-clinical-features-evaluation-and-diagnosis</a:t>
            </a:r>
          </a:p>
          <a:p>
            <a:r>
              <a:rPr lang="en-US" dirty="0"/>
              <a:t>3. Service F, Cryer P, Vella A. Hypoglycemia in adults without diabetes mellitus: Clinical manifestations, diagnosis, and causes. Uptodate.com. Updated February 9, 2021. Accessed March 12, 2021. Available at: </a:t>
            </a:r>
            <a:r>
              <a:rPr lang="en-US" dirty="0">
                <a:ea typeface="+mn-lt"/>
                <a:cs typeface="+mn-lt"/>
                <a:hlinkClick r:id="rId4"/>
              </a:rPr>
              <a:t>https://www.uptodate.com/contents/hypoglycemia-in-adults-without-diabetes-mellitus-clinical-manifestations-diagnosis-and-causes</a:t>
            </a:r>
            <a:endParaRPr lang="en-US" dirty="0">
              <a:ea typeface="+mn-lt"/>
              <a:cs typeface="+mn-lt"/>
            </a:endParaRPr>
          </a:p>
          <a:p>
            <a:endParaRPr lang="en-US" dirty="0">
              <a:cs typeface="Arial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AB64E0D-C89F-314E-B664-2FBBBCE9BF11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1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95444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NORMO</a:t>
            </a:r>
            <a:r>
              <a:rPr lang="en-US" dirty="0"/>
              <a:t>GLYCEMIA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Fasting Plasma Glucose (FPG) &lt;100 mg/dL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2-hour glucose during Oral Glucose Tolerance Test (OGTT) &lt;140 mg/dL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964417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BA50E6-273C-9A43-A4F5-C2AA5E38C4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EFINITION OF </a:t>
            </a:r>
            <a:r>
              <a:rPr lang="en-US" i="1" dirty="0"/>
              <a:t>HYPER</a:t>
            </a:r>
            <a:r>
              <a:rPr lang="en-US" dirty="0"/>
              <a:t>GLYC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D9AC89-15B8-ED4D-9349-9010135C026D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685800" y="1190935"/>
            <a:ext cx="7123922" cy="3515317"/>
          </a:xfrm>
        </p:spPr>
        <p:txBody>
          <a:bodyPr>
            <a:normAutofit fontScale="92500"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Diabetes mellitus is diagnosed differently depending on whether symptoms are present or not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Symptomatic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With random blood glucose ≥ 200 mg/dL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symptomatic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FPG ≥ 126 mg/dL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2-hour plasma glucose during OGTT ≥ 200 mg/dL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HbA1c ≥ 6.5%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Any of the above criteria must be met on subsequent days by repeating the same diagnostic test for confirmation, OR two of the above tests performed are diagnostic 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DCA738-FB7A-4C46-B860-2B531AE06FCA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901525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BA50E6-273C-9A43-A4F5-C2AA5E38C4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USES OF </a:t>
            </a:r>
            <a:r>
              <a:rPr lang="en-US" i="1" dirty="0"/>
              <a:t>HYPER</a:t>
            </a:r>
            <a:r>
              <a:rPr lang="en-US" dirty="0"/>
              <a:t>GLYC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D9AC89-15B8-ED4D-9349-9010135C026D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Diabetes mellitu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Exogenous steroid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Severe illness, also known as stress hyperglycemia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Due to increased serum cortisol, glucagon, catecholamines, glucagon, growth hormone causing increased gluconeogenesis &amp; glycogenolysis causing insulin resistance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DCA738-FB7A-4C46-B860-2B531AE06FCA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62169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389204-0357-6842-AE76-E923C5C98F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YMPTOMS OF </a:t>
            </a:r>
            <a:r>
              <a:rPr lang="en-US" i="1" dirty="0"/>
              <a:t>HYPER</a:t>
            </a:r>
            <a:r>
              <a:rPr lang="en-US" dirty="0"/>
              <a:t>GLYC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799467-24F6-214B-A29E-040F66D8BFCC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Thirst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Hunger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Frequent urination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Blurry vision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Weight los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57D036-FFAB-984C-B816-D71863826828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746163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E90F9C-57B6-7140-A73E-6B57F78FA4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HYPER</a:t>
            </a:r>
            <a:r>
              <a:rPr lang="en-US" dirty="0"/>
              <a:t>GLYCEMIA</a:t>
            </a:r>
            <a:br>
              <a:rPr lang="en-US" dirty="0"/>
            </a:br>
            <a:r>
              <a:rPr lang="en-US" u="sng" dirty="0"/>
              <a:t>EXCLUSION</a:t>
            </a:r>
            <a:r>
              <a:rPr lang="en-US" dirty="0"/>
              <a:t> CRITERIA FOR OBSERV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E126B9-F0C8-CF45-9BAE-E6587958F48B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Diabetic ketoacidosis</a:t>
            </a:r>
          </a:p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ketoacidosis, pH &lt; 7.3, serum bicarb &lt; 18, anion gap &gt; 12</a:t>
            </a:r>
          </a:p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Hyperosmolar </a:t>
            </a:r>
            <a:r>
              <a:rPr lang="en-US" dirty="0">
                <a:solidFill>
                  <a:schemeClr val="bg1"/>
                </a:solidFill>
              </a:rPr>
              <a:t>hyperglycemic state/ hyperosmotic hyperglycemic nonketotic state (HHS/ HHNK)</a:t>
            </a:r>
          </a:p>
          <a:p>
            <a:pPr lvl="1">
              <a:buFont typeface="Wingdings" pitchFamily="2" charset="2"/>
              <a:buChar char="Ø"/>
            </a:pPr>
            <a:r>
              <a:rPr lang="en-US" dirty="0">
                <a:solidFill>
                  <a:schemeClr val="bg1"/>
                </a:solidFill>
              </a:rPr>
              <a:t>Altered mental status, serum </a:t>
            </a:r>
            <a:r>
              <a:rPr lang="en-US" dirty="0"/>
              <a:t>glucose &gt; 600, serum </a:t>
            </a:r>
            <a:r>
              <a:rPr lang="en-US" dirty="0" err="1"/>
              <a:t>Osm</a:t>
            </a:r>
            <a:r>
              <a:rPr lang="en-US" dirty="0"/>
              <a:t> &gt; 320</a:t>
            </a:r>
            <a:r>
              <a:rPr lang="en-US" b="1" dirty="0"/>
              <a:t> </a:t>
            </a:r>
            <a:r>
              <a:rPr lang="en-US" b="1" i="1" dirty="0"/>
              <a:t>DESPITE</a:t>
            </a:r>
            <a:r>
              <a:rPr lang="en-US" dirty="0"/>
              <a:t> pH &gt; 7.3, serum bicarb &gt; 15, little to no ketones in urine</a:t>
            </a:r>
          </a:p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81A5F95-E7F3-EC4D-8914-94DDBCD81A60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894753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C6A220-EAC7-6143-B9DB-961AC85298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i="1" dirty="0"/>
              <a:t>HYPER</a:t>
            </a:r>
            <a:r>
              <a:rPr lang="en-US" dirty="0"/>
              <a:t>GLYCEMIA</a:t>
            </a:r>
            <a:br>
              <a:rPr lang="en-US" dirty="0"/>
            </a:br>
            <a:r>
              <a:rPr lang="en-US" dirty="0"/>
              <a:t>MANAGEMENT DURING OBSERV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3AF7B0-516C-D846-B64D-E1D1DD52EFB3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 vert="horz" lIns="0" tIns="0" rIns="0" bIns="0" rtlCol="0" anchor="t">
            <a:normAutofit/>
          </a:bodyPr>
          <a:lstStyle/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Initiate long and short-acting Insulin</a:t>
            </a:r>
          </a:p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Regular Insulin Sliding Scale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Monitor blood glucose check q4 hours</a:t>
            </a:r>
            <a:endParaRPr lang="en-US" dirty="0">
              <a:cs typeface="Arial"/>
            </a:endParaRPr>
          </a:p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Supplement potassium for goal K ~4</a:t>
            </a:r>
          </a:p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Diabetic diet</a:t>
            </a:r>
          </a:p>
          <a:p>
            <a:pPr marL="285750" lvl="0" indent="-285750">
              <a:buFont typeface="Courier New" panose="02070309020205020404" pitchFamily="49" charset="0"/>
              <a:buChar char="o"/>
            </a:pPr>
            <a:r>
              <a:rPr lang="en-US" dirty="0"/>
              <a:t>Glycemic control consult</a:t>
            </a:r>
          </a:p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65DE727-CD0B-FB48-A1D1-FFDC2B09735F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08961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BA50E6-273C-9A43-A4F5-C2AA5E38C4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EFINITION OF </a:t>
            </a:r>
            <a:r>
              <a:rPr lang="en-US" i="1" dirty="0"/>
              <a:t>HYPO</a:t>
            </a:r>
            <a:r>
              <a:rPr lang="en-US" dirty="0"/>
              <a:t>GLYC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D9AC89-15B8-ED4D-9349-9010135C026D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>
            <a:normAutofit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Lower limit of normal fasting plasma glucose is 70 mg/dL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Onset of symptoms typically occur with plasma glucose ≤ 54 mg/dL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Hypoglycemic disorder can only be diagnosed if Whipple’s Triad is met: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Symptoms are present that may relate to hypoglycemia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Plasma glucose concentrations are low while symptoms are present</a:t>
            </a:r>
          </a:p>
          <a:p>
            <a:pPr marL="788670" lvl="1" indent="-285750">
              <a:buFont typeface="Wingdings" pitchFamily="2" charset="2"/>
              <a:buChar char="Ø"/>
            </a:pPr>
            <a:r>
              <a:rPr lang="en-US" dirty="0"/>
              <a:t>Symptoms are relieved by correction of hypoglycemia with administration of glucose or glucago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DCA738-FB7A-4C46-B860-2B531AE06FCA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873711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BA50E6-273C-9A43-A4F5-C2AA5E38C4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USES OF </a:t>
            </a:r>
            <a:r>
              <a:rPr lang="en-US" i="1" dirty="0"/>
              <a:t>HYPO</a:t>
            </a:r>
            <a:r>
              <a:rPr lang="en-US" dirty="0"/>
              <a:t>GLYCEM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D9AC89-15B8-ED4D-9349-9010135C026D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>
            <a:normAutofit lnSpcReduction="10000"/>
          </a:bodyPr>
          <a:lstStyle/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Drugs (ie, Insulin, Meglitinides, Sulfonylureas, Quinolones, Angiotensin converting enzyme inhibitors (ACE-I), (B-blockers)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Critical Illness (ie, sepsis)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Malnourishment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Ethanol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Cortisol deficiency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Non-islet cell tumors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Endogenous hyperinsulinism (ie, Insulinoma, Insulin autoimmune hypoglycemia, beta cell secretagogue, non-insulinoma pancreatogenous hypoglycemia syndrome)</a:t>
            </a:r>
          </a:p>
          <a:p>
            <a:pPr marL="285750" indent="-285750">
              <a:buFont typeface="Courier New" panose="02070309020205020404" pitchFamily="49" charset="0"/>
              <a:buChar char="o"/>
            </a:pPr>
            <a:r>
              <a:rPr lang="en-US" dirty="0"/>
              <a:t>Accidental, malicious, or surreptitious intake of hypoglycemic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DCA738-FB7A-4C46-B860-2B531AE06FCA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E0E041CE-D44E-914D-B85F-4D1E25348469}" type="slidenum">
              <a:rPr lang="en-US" smtClean="0"/>
              <a:pPr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4719234"/>
      </p:ext>
    </p:extLst>
  </p:cSld>
  <p:clrMapOvr>
    <a:masterClrMapping/>
  </p:clrMapOvr>
</p:sld>
</file>

<file path=ppt/theme/theme1.xml><?xml version="1.0" encoding="utf-8"?>
<a:theme xmlns:a="http://schemas.openxmlformats.org/drawingml/2006/main" name="NYULMC_160829_16x9-Dark_+Boilerplates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Langone_082616_16x9-Dark" id="{16CBEE8A-9587-4812-992D-3553C1FB98F7}" vid="{3F59DFCD-48A1-483A-ADCD-1B4B54D76525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Version xmlns="http://schemas.microsoft.com/sharepoint/v3/fields" xsi:nil="true"/>
    <_Status xmlns="http://schemas.microsoft.com/sharepoint/v3/fields">Not Started</_Status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E64AEEDD9B7A4D93545ACBE97D4615" ma:contentTypeVersion="2" ma:contentTypeDescription="Create a new document." ma:contentTypeScope="" ma:versionID="f49002b78e3a4a71b814eef46a983816">
  <xsd:schema xmlns:xsd="http://www.w3.org/2001/XMLSchema" xmlns:xs="http://www.w3.org/2001/XMLSchema" xmlns:p="http://schemas.microsoft.com/office/2006/metadata/properties" xmlns:ns2="http://schemas.microsoft.com/sharepoint/v3/fields" targetNamespace="http://schemas.microsoft.com/office/2006/metadata/properties" ma:root="true" ma:fieldsID="38f6db2dd0d9a0cf6a8dc37be32b365b" ns2:_="">
    <xsd:import namespace="http://schemas.microsoft.com/sharepoint/v3/fields"/>
    <xsd:element name="properties">
      <xsd:complexType>
        <xsd:sequence>
          <xsd:element name="documentManagement">
            <xsd:complexType>
              <xsd:all>
                <xsd:element ref="ns2:_Status" minOccurs="0"/>
                <xsd:element ref="ns2:_Vers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/fields" elementFormDefault="qualified">
    <xsd:import namespace="http://schemas.microsoft.com/office/2006/documentManagement/types"/>
    <xsd:import namespace="http://schemas.microsoft.com/office/infopath/2007/PartnerControls"/>
    <xsd:element name="_Status" ma:index="8" nillable="true" ma:displayName="Status" ma:default="Not Started" ma:internalName="_Status">
      <xsd:simpleType>
        <xsd:union memberTypes="dms:Text">
          <xsd:simpleType>
            <xsd:restriction base="dms:Choice">
              <xsd:enumeration value="Not Started"/>
              <xsd:enumeration value="Draft"/>
              <xsd:enumeration value="Reviewed"/>
              <xsd:enumeration value="Scheduled"/>
              <xsd:enumeration value="Published"/>
              <xsd:enumeration value="Final"/>
              <xsd:enumeration value="Expired"/>
            </xsd:restriction>
          </xsd:simpleType>
        </xsd:union>
      </xsd:simpleType>
    </xsd:element>
    <xsd:element name="_Version" ma:index="9" nillable="true" ma:displayName="Version" ma:internalName="_Version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 ma:displayName="Status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B6F2769-7194-4217-93D3-3AF3A4742282}">
  <ds:schemaRefs>
    <ds:schemaRef ds:uri="http://purl.org/dc/elements/1.1/"/>
    <ds:schemaRef ds:uri="http://schemas.microsoft.com/office/2006/metadata/properties"/>
    <ds:schemaRef ds:uri="http://schemas.microsoft.com/office/2006/documentManagement/typ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schemas.microsoft.com/sharepoint/v3/field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87D2A1B0-FF3E-4009-940D-AED0EB70AA2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4214858-785C-42F7-BE66-6D0E79395FC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/fields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NYULMC_160829_16x9-Dark</Template>
  <TotalTime>39410</TotalTime>
  <Words>865</Words>
  <Application>Microsoft Macintosh PowerPoint</Application>
  <PresentationFormat>On-screen Show (16:9)</PresentationFormat>
  <Paragraphs>123</Paragraphs>
  <Slides>1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2" baseType="lpstr">
      <vt:lpstr>Arial</vt:lpstr>
      <vt:lpstr>Calibri</vt:lpstr>
      <vt:lpstr>Courier New</vt:lpstr>
      <vt:lpstr>Lucida Grande</vt:lpstr>
      <vt:lpstr>Wingdings</vt:lpstr>
      <vt:lpstr>NYULMC_160829_16x9-Dark_+Boilerplates</vt:lpstr>
      <vt:lpstr>HYPER &amp; HYPOGLYCEMIA  Managing DYSGLYCEMIA</vt:lpstr>
      <vt:lpstr>NORMOGLYCEMIA</vt:lpstr>
      <vt:lpstr>DEFINITION OF HYPERGLYCEMIA</vt:lpstr>
      <vt:lpstr>CAUSES OF HYPERGLYCEMIA</vt:lpstr>
      <vt:lpstr>SYMPTOMS OF HYPERGLYCEMIA</vt:lpstr>
      <vt:lpstr>HYPERGLYCEMIA EXCLUSION CRITERIA FOR OBSERVATION</vt:lpstr>
      <vt:lpstr>HYPERGLYCEMIA MANAGEMENT DURING OBSERVATION</vt:lpstr>
      <vt:lpstr>DEFINITION OF HYPOGLYCEMIA</vt:lpstr>
      <vt:lpstr>CAUSES OF HYPOGLYCEMIA</vt:lpstr>
      <vt:lpstr>SYMPTOMS OF HYPOGLYCEMIA</vt:lpstr>
      <vt:lpstr>HYPOGLYCEMIA EXCLUSION CRITERIA FOR OBSERVATION</vt:lpstr>
      <vt:lpstr>HYPOGLYCEMIA MANAGEMENT DURING OBSERVATION</vt:lpstr>
      <vt:lpstr>HOW TO PREVENT HYPOGLYCEMIA</vt:lpstr>
      <vt:lpstr>15-15 RULE OF HYPOGLYCEMIA</vt:lpstr>
      <vt:lpstr>WHEN TO ADMIT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DICATION RECONCILIATION</dc:title>
  <dc:creator>Barie Salmon</dc:creator>
  <cp:lastModifiedBy>Alisa Wray</cp:lastModifiedBy>
  <cp:revision>155</cp:revision>
  <dcterms:created xsi:type="dcterms:W3CDTF">2017-06-02T12:45:43Z</dcterms:created>
  <dcterms:modified xsi:type="dcterms:W3CDTF">2021-04-12T19:02:25Z</dcterms:modified>
  <cp:contentStatus>Draft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E64AEEDD9B7A4D93545ACBE97D4615</vt:lpwstr>
  </property>
</Properties>
</file>